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34200" cy="92344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F128F-333F-4F50-A0BE-DDB46CEB79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D1CDB-82EA-43ED-89D9-BBA9757BB5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22237-5E12-41D6-9EB0-53384655C9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AB627-FB8D-40A2-B413-3078F05AE5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08512-E931-42CD-BD9B-3C95072E62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A0434-260C-4212-938A-97472930AA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608B3-967D-46FD-AC15-ED65AA0D30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795DB-AA81-4646-8525-720655C097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AB5BD-495D-4C6A-B58A-EB092BE0C6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BC4CF-CDEB-4C7A-9A68-A14B53311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8A9A8-CEF9-448E-B0EB-AE74E2C5D3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63DEF-2966-489E-947D-39AB84DAD0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45CAA0-9733-4411-BAAC-2FD0836A0199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490"/>
          <p:cNvSpPr/>
          <p:nvPr/>
        </p:nvSpPr>
        <p:spPr>
          <a:xfrm flipV="1">
            <a:off x="4797360" y="8748360"/>
            <a:ext cx="1152720" cy="126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165 Conector angular"/>
          <p:cNvCxnSpPr>
            <a:stCxn id="43" idx="1"/>
          </p:cNvCxnSpPr>
          <p:nvPr/>
        </p:nvCxnSpPr>
        <p:spPr>
          <a:xfrm rot="10800000">
            <a:off x="3561840" y="3132360"/>
            <a:ext cx="515160" cy="3414600"/>
          </a:xfrm>
          <a:prstGeom prst="bentConnector3">
            <a:avLst>
              <a:gd name="adj1" fmla="val 72027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4" name="Line 1153"/>
          <p:cNvSpPr/>
          <p:nvPr/>
        </p:nvSpPr>
        <p:spPr>
          <a:xfrm flipH="1">
            <a:off x="1989000" y="1806480"/>
            <a:ext cx="266400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205"/>
          <p:cNvSpPr/>
          <p:nvPr/>
        </p:nvSpPr>
        <p:spPr>
          <a:xfrm>
            <a:off x="3349800" y="468360"/>
            <a:ext cx="0" cy="8269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42"/>
          <p:cNvSpPr/>
          <p:nvPr/>
        </p:nvSpPr>
        <p:spPr>
          <a:xfrm>
            <a:off x="4869000" y="1006560"/>
            <a:ext cx="0" cy="71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72 Rectángulo redondeado"/>
          <p:cNvSpPr/>
          <p:nvPr/>
        </p:nvSpPr>
        <p:spPr>
          <a:xfrm>
            <a:off x="1695600" y="4932360"/>
            <a:ext cx="3143160" cy="3456000"/>
          </a:xfrm>
          <a:custGeom>
            <a:avLst/>
            <a:gdLst>
              <a:gd name="textAreaLeft" fmla="*/ 153360 w 3143160"/>
              <a:gd name="textAreaRight" fmla="*/ 2989800 w 3143160"/>
              <a:gd name="textAreaTop" fmla="*/ 153360 h 3456000"/>
              <a:gd name="textAreaBottom" fmla="*/ 3302640 h 3456000"/>
            </a:gdLst>
            <a:ahLst/>
            <a:rect l="textAreaLeft" t="textAreaTop" r="textAreaRight" b="textAreaBottom"/>
            <a:pathLst>
              <a:path w="21600" h="23750">
                <a:moveTo>
                  <a:pt x="3600" y="0"/>
                </a:moveTo>
                <a:arcTo wR="3600" hR="3600" stAng="16200000" swAng="-5400000"/>
                <a:lnTo>
                  <a:pt x="0" y="20150"/>
                </a:lnTo>
                <a:arcTo wR="3600" hR="3600" stAng="10800000" swAng="-5400000"/>
                <a:lnTo>
                  <a:pt x="18000" y="2375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6"/>
          <p:cNvSpPr/>
          <p:nvPr/>
        </p:nvSpPr>
        <p:spPr>
          <a:xfrm>
            <a:off x="3057480" y="250920"/>
            <a:ext cx="649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GLC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8"/>
          <p:cNvSpPr/>
          <p:nvPr/>
        </p:nvSpPr>
        <p:spPr>
          <a:xfrm flipH="1">
            <a:off x="3343320" y="2433600"/>
            <a:ext cx="1440" cy="538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2"/>
          <p:cNvSpPr/>
          <p:nvPr/>
        </p:nvSpPr>
        <p:spPr>
          <a:xfrm>
            <a:off x="3129120" y="13190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G6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7"/>
          <p:cNvSpPr/>
          <p:nvPr/>
        </p:nvSpPr>
        <p:spPr>
          <a:xfrm>
            <a:off x="3176640" y="2211480"/>
            <a:ext cx="43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F6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8"/>
          <p:cNvSpPr/>
          <p:nvPr/>
        </p:nvSpPr>
        <p:spPr>
          <a:xfrm>
            <a:off x="3127320" y="297180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GA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0"/>
          <p:cNvSpPr/>
          <p:nvPr/>
        </p:nvSpPr>
        <p:spPr>
          <a:xfrm>
            <a:off x="3129120" y="40892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PY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1"/>
          <p:cNvSpPr/>
          <p:nvPr/>
        </p:nvSpPr>
        <p:spPr>
          <a:xfrm>
            <a:off x="4653000" y="814320"/>
            <a:ext cx="503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RU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4"/>
          <p:cNvSpPr/>
          <p:nvPr/>
        </p:nvSpPr>
        <p:spPr>
          <a:xfrm>
            <a:off x="4653000" y="1692360"/>
            <a:ext cx="44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XU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5"/>
          <p:cNvSpPr/>
          <p:nvPr/>
        </p:nvSpPr>
        <p:spPr>
          <a:xfrm>
            <a:off x="5877000" y="169236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R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1"/>
          <p:cNvSpPr/>
          <p:nvPr/>
        </p:nvSpPr>
        <p:spPr>
          <a:xfrm>
            <a:off x="3022560" y="5419800"/>
            <a:ext cx="647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ACCO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3"/>
          <p:cNvSpPr/>
          <p:nvPr/>
        </p:nvSpPr>
        <p:spPr>
          <a:xfrm>
            <a:off x="4076640" y="643104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CI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4"/>
          <p:cNvSpPr/>
          <p:nvPr/>
        </p:nvSpPr>
        <p:spPr>
          <a:xfrm>
            <a:off x="4005360" y="7643880"/>
            <a:ext cx="431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A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65"/>
          <p:cNvSpPr/>
          <p:nvPr/>
        </p:nvSpPr>
        <p:spPr>
          <a:xfrm>
            <a:off x="2112840" y="758016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MA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69"/>
          <p:cNvSpPr/>
          <p:nvPr/>
        </p:nvSpPr>
        <p:spPr>
          <a:xfrm>
            <a:off x="2112840" y="628344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O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rc 76"/>
          <p:cNvSpPr/>
          <p:nvPr/>
        </p:nvSpPr>
        <p:spPr>
          <a:xfrm rot="10612200">
            <a:off x="3354120" y="5624280"/>
            <a:ext cx="288720" cy="396720"/>
          </a:xfrm>
          <a:custGeom>
            <a:avLst/>
            <a:gdLst>
              <a:gd name="textAreaLeft" fmla="*/ 0 w 288720"/>
              <a:gd name="textAreaRight" fmla="*/ 289080 w 288720"/>
              <a:gd name="textAreaTop" fmla="*/ 0 h 396720"/>
              <a:gd name="textAreaBottom" fmla="*/ 397080 h 396720"/>
            </a:gdLst>
            <a:ahLst/>
            <a:rect l="textAreaLeft" t="textAreaTop" r="textAreaRight" b="textAreaBottom"/>
            <a:pathLst>
              <a:path fill="none" w="21600" h="23609">
                <a:moveTo>
                  <a:pt x="4228" y="-1"/>
                </a:moveTo>
                <a:cubicBezTo>
                  <a:pt x="14328" y="2015"/>
                  <a:pt x="21600" y="10882"/>
                  <a:pt x="21600" y="21182"/>
                </a:cubicBezTo>
                <a:cubicBezTo>
                  <a:pt x="21600" y="21992"/>
                  <a:pt x="21554" y="22803"/>
                  <a:pt x="21463" y="23609"/>
                </a:cubicBezTo>
              </a:path>
              <a:path stroke="0" w="21600" h="23609">
                <a:moveTo>
                  <a:pt x="4228" y="-1"/>
                </a:moveTo>
                <a:cubicBezTo>
                  <a:pt x="14328" y="2015"/>
                  <a:pt x="21600" y="10882"/>
                  <a:pt x="21600" y="21182"/>
                </a:cubicBezTo>
                <a:cubicBezTo>
                  <a:pt x="21600" y="21992"/>
                  <a:pt x="21554" y="22803"/>
                  <a:pt x="21463" y="23609"/>
                </a:cubicBezTo>
                <a:lnTo>
                  <a:pt x="0" y="21182"/>
                </a:lnTo>
                <a:lnTo>
                  <a:pt x="4228" y="-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80"/>
          <p:cNvSpPr/>
          <p:nvPr/>
        </p:nvSpPr>
        <p:spPr>
          <a:xfrm>
            <a:off x="3500280" y="4210200"/>
            <a:ext cx="151308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81"/>
          <p:cNvSpPr/>
          <p:nvPr/>
        </p:nvSpPr>
        <p:spPr>
          <a:xfrm>
            <a:off x="5013360" y="4084560"/>
            <a:ext cx="647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ACCO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3"/>
          <p:cNvSpPr/>
          <p:nvPr/>
        </p:nvSpPr>
        <p:spPr>
          <a:xfrm>
            <a:off x="5657760" y="29750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S7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4"/>
          <p:cNvSpPr/>
          <p:nvPr/>
        </p:nvSpPr>
        <p:spPr>
          <a:xfrm>
            <a:off x="4653000" y="22114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E4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181 Conector recto de flecha"/>
          <p:cNvCxnSpPr>
            <a:stCxn id="53" idx="2"/>
            <a:endCxn id="57" idx="0"/>
          </p:cNvCxnSpPr>
          <p:nvPr/>
        </p:nvCxnSpPr>
        <p:spPr>
          <a:xfrm>
            <a:off x="3344760" y="4320360"/>
            <a:ext cx="1800" cy="1099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7" name="Text Box 17"/>
          <p:cNvSpPr/>
          <p:nvPr/>
        </p:nvSpPr>
        <p:spPr>
          <a:xfrm rot="16200000">
            <a:off x="4377600" y="5469480"/>
            <a:ext cx="933480" cy="4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Mitochondri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Cytos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8" name="163 Conector angular"/>
          <p:cNvCxnSpPr/>
          <p:nvPr/>
        </p:nvCxnSpPr>
        <p:spPr>
          <a:xfrm>
            <a:off x="5032440" y="1812960"/>
            <a:ext cx="630720" cy="1318320"/>
          </a:xfrm>
          <a:prstGeom prst="bentConnector3">
            <a:avLst>
              <a:gd name="adj1" fmla="val 44031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9" name="175 Conector angular"/>
          <p:cNvCxnSpPr/>
          <p:nvPr/>
        </p:nvCxnSpPr>
        <p:spPr>
          <a:xfrm flipV="1">
            <a:off x="3578040" y="2339640"/>
            <a:ext cx="1122840" cy="720000"/>
          </a:xfrm>
          <a:prstGeom prst="bentConnector3">
            <a:avLst>
              <a:gd name="adj1" fmla="val 6731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0" name="178 Conector angular"/>
          <p:cNvCxnSpPr/>
          <p:nvPr/>
        </p:nvCxnSpPr>
        <p:spPr>
          <a:xfrm>
            <a:off x="3565080" y="2340000"/>
            <a:ext cx="2071080" cy="720000"/>
          </a:xfrm>
          <a:prstGeom prst="bentConnector3">
            <a:avLst>
              <a:gd name="adj1" fmla="val 36961"/>
            </a:avLst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71" name="187 Forma"/>
          <p:cNvCxnSpPr/>
          <p:nvPr/>
        </p:nvCxnSpPr>
        <p:spPr>
          <a:xfrm flipV="1" rot="16200000">
            <a:off x="4714560" y="2053800"/>
            <a:ext cx="126000" cy="183240"/>
          </a:xfrm>
          <a:prstGeom prst="bentConnector2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72" name="189 Forma"/>
          <p:cNvCxnSpPr>
            <a:stCxn id="57" idx="2"/>
          </p:cNvCxnSpPr>
          <p:nvPr/>
        </p:nvCxnSpPr>
        <p:spPr>
          <a:xfrm flipH="1" flipV="1" rot="5400000">
            <a:off x="2150640" y="3276720"/>
            <a:ext cx="3569760" cy="1179360"/>
          </a:xfrm>
          <a:prstGeom prst="bentConnector3">
            <a:avLst>
              <a:gd name="adj1" fmla="val -6364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73" name="198 Forma"/>
          <p:cNvCxnSpPr/>
          <p:nvPr/>
        </p:nvCxnSpPr>
        <p:spPr>
          <a:xfrm flipH="1" flipV="1" rot="5400000">
            <a:off x="3504960" y="2010960"/>
            <a:ext cx="892800" cy="1032480"/>
          </a:xfrm>
          <a:prstGeom prst="curved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74" name="205 Forma"/>
          <p:cNvCxnSpPr/>
          <p:nvPr/>
        </p:nvCxnSpPr>
        <p:spPr>
          <a:xfrm flipH="1" flipV="1" rot="5400000">
            <a:off x="3893760" y="1578240"/>
            <a:ext cx="132480" cy="1134360"/>
          </a:xfrm>
          <a:prstGeom prst="curved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75" name="Line 117"/>
          <p:cNvSpPr/>
          <p:nvPr/>
        </p:nvSpPr>
        <p:spPr>
          <a:xfrm>
            <a:off x="1844640" y="3059280"/>
            <a:ext cx="133200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rc 129"/>
          <p:cNvSpPr/>
          <p:nvPr/>
        </p:nvSpPr>
        <p:spPr>
          <a:xfrm flipH="1" rot="757800">
            <a:off x="2418120" y="5951520"/>
            <a:ext cx="1695600" cy="1131840"/>
          </a:xfrm>
          <a:custGeom>
            <a:avLst/>
            <a:gdLst>
              <a:gd name="textAreaLeft" fmla="*/ 360 w 1695600"/>
              <a:gd name="textAreaRight" fmla="*/ 1696320 w 1695600"/>
              <a:gd name="textAreaTop" fmla="*/ 0 h 1131840"/>
              <a:gd name="textAreaBottom" fmla="*/ 1132200 h 1131840"/>
            </a:gdLst>
            <a:ahLst/>
            <a:rect l="textAreaLeft" t="textAreaTop" r="textAreaRight" b="textAreaBottom"/>
            <a:pathLst>
              <a:path fill="none" w="32607" h="21600">
                <a:moveTo>
                  <a:pt x="0" y="5652"/>
                </a:moveTo>
                <a:cubicBezTo>
                  <a:pt x="3980" y="2016"/>
                  <a:pt x="9176" y="-1"/>
                  <a:pt x="14568" y="0"/>
                </a:cubicBezTo>
                <a:cubicBezTo>
                  <a:pt x="21832" y="0"/>
                  <a:pt x="28610" y="3651"/>
                  <a:pt x="32606" y="9719"/>
                </a:cubicBezTo>
              </a:path>
              <a:path stroke="0" w="32607" h="21600">
                <a:moveTo>
                  <a:pt x="0" y="5652"/>
                </a:moveTo>
                <a:cubicBezTo>
                  <a:pt x="3980" y="2016"/>
                  <a:pt x="9176" y="-1"/>
                  <a:pt x="14568" y="0"/>
                </a:cubicBezTo>
                <a:cubicBezTo>
                  <a:pt x="21832" y="0"/>
                  <a:pt x="28610" y="3651"/>
                  <a:pt x="32606" y="9719"/>
                </a:cubicBezTo>
                <a:lnTo>
                  <a:pt x="14568" y="21600"/>
                </a:lnTo>
                <a:lnTo>
                  <a:pt x="0" y="565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Arc 130"/>
          <p:cNvSpPr/>
          <p:nvPr/>
        </p:nvSpPr>
        <p:spPr>
          <a:xfrm flipH="1" rot="757800">
            <a:off x="3252240" y="6603480"/>
            <a:ext cx="1123920" cy="912960"/>
          </a:xfrm>
          <a:custGeom>
            <a:avLst/>
            <a:gdLst>
              <a:gd name="textAreaLeft" fmla="*/ 360 w 1123920"/>
              <a:gd name="textAreaRight" fmla="*/ 1124640 w 1123920"/>
              <a:gd name="textAreaTop" fmla="*/ 0 h 912960"/>
              <a:gd name="textAreaBottom" fmla="*/ 913320 h 912960"/>
            </a:gdLst>
            <a:ahLst/>
            <a:rect l="textAreaLeft" t="textAreaTop" r="textAreaRight" b="textAreaBottom"/>
            <a:pathLst>
              <a:path fill="none" w="21600" h="17415">
                <a:moveTo>
                  <a:pt x="781" y="17415"/>
                </a:moveTo>
                <a:cubicBezTo>
                  <a:pt x="263" y="15539"/>
                  <a:pt x="0" y="13602"/>
                  <a:pt x="0" y="11656"/>
                </a:cubicBezTo>
                <a:cubicBezTo>
                  <a:pt x="-1" y="7523"/>
                  <a:pt x="1185" y="3478"/>
                  <a:pt x="3414" y="-1"/>
                </a:cubicBezTo>
              </a:path>
              <a:path stroke="0" w="21600" h="17415">
                <a:moveTo>
                  <a:pt x="781" y="17415"/>
                </a:moveTo>
                <a:cubicBezTo>
                  <a:pt x="263" y="15539"/>
                  <a:pt x="0" y="13602"/>
                  <a:pt x="0" y="11656"/>
                </a:cubicBezTo>
                <a:cubicBezTo>
                  <a:pt x="-1" y="7523"/>
                  <a:pt x="1185" y="3478"/>
                  <a:pt x="3414" y="-1"/>
                </a:cubicBezTo>
                <a:lnTo>
                  <a:pt x="21600" y="11656"/>
                </a:lnTo>
                <a:lnTo>
                  <a:pt x="781" y="17415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rc 131"/>
          <p:cNvSpPr/>
          <p:nvPr/>
        </p:nvSpPr>
        <p:spPr>
          <a:xfrm flipH="1" rot="757800">
            <a:off x="2412360" y="7105320"/>
            <a:ext cx="1673280" cy="1131840"/>
          </a:xfrm>
          <a:custGeom>
            <a:avLst/>
            <a:gdLst>
              <a:gd name="textAreaLeft" fmla="*/ 360 w 1673280"/>
              <a:gd name="textAreaRight" fmla="*/ 1674000 w 1673280"/>
              <a:gd name="textAreaTop" fmla="*/ 0 h 1131840"/>
              <a:gd name="textAreaBottom" fmla="*/ 1132200 h 1131840"/>
            </a:gdLst>
            <a:ahLst/>
            <a:rect l="textAreaLeft" t="textAreaTop" r="textAreaRight" b="textAreaBottom"/>
            <a:pathLst>
              <a:path fill="none" w="32158" h="21600">
                <a:moveTo>
                  <a:pt x="32158" y="16954"/>
                </a:moveTo>
                <a:cubicBezTo>
                  <a:pt x="28346" y="19963"/>
                  <a:pt x="23631" y="21599"/>
                  <a:pt x="18775" y="21600"/>
                </a:cubicBezTo>
                <a:cubicBezTo>
                  <a:pt x="11008" y="21600"/>
                  <a:pt x="3840" y="17430"/>
                  <a:pt x="0" y="10680"/>
                </a:cubicBezTo>
              </a:path>
              <a:path stroke="0" w="32158" h="21600">
                <a:moveTo>
                  <a:pt x="32158" y="16954"/>
                </a:moveTo>
                <a:cubicBezTo>
                  <a:pt x="28346" y="19963"/>
                  <a:pt x="23631" y="21599"/>
                  <a:pt x="18775" y="21600"/>
                </a:cubicBezTo>
                <a:cubicBezTo>
                  <a:pt x="11008" y="21600"/>
                  <a:pt x="3840" y="17430"/>
                  <a:pt x="0" y="10680"/>
                </a:cubicBezTo>
                <a:lnTo>
                  <a:pt x="18775" y="0"/>
                </a:lnTo>
                <a:lnTo>
                  <a:pt x="32158" y="16954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rc 132"/>
          <p:cNvSpPr/>
          <p:nvPr/>
        </p:nvSpPr>
        <p:spPr>
          <a:xfrm flipH="1" rot="757800">
            <a:off x="2082240" y="6654600"/>
            <a:ext cx="1123920" cy="995040"/>
          </a:xfrm>
          <a:custGeom>
            <a:avLst/>
            <a:gdLst>
              <a:gd name="textAreaLeft" fmla="*/ 360 w 1123920"/>
              <a:gd name="textAreaRight" fmla="*/ 1124640 w 1123920"/>
              <a:gd name="textAreaTop" fmla="*/ 0 h 995040"/>
              <a:gd name="textAreaBottom" fmla="*/ 995400 h 995040"/>
            </a:gdLst>
            <a:ahLst/>
            <a:rect l="textAreaLeft" t="textAreaTop" r="textAreaRight" b="textAreaBottom"/>
            <a:pathLst>
              <a:path fill="none" w="21600" h="19001">
                <a:moveTo>
                  <a:pt x="20798" y="0"/>
                </a:moveTo>
                <a:cubicBezTo>
                  <a:pt x="21330" y="1897"/>
                  <a:pt x="21600" y="3857"/>
                  <a:pt x="21600" y="5828"/>
                </a:cubicBezTo>
                <a:cubicBezTo>
                  <a:pt x="21600" y="10593"/>
                  <a:pt x="20024" y="15224"/>
                  <a:pt x="17118" y="19001"/>
                </a:cubicBezTo>
              </a:path>
              <a:path stroke="0" w="21600" h="19001">
                <a:moveTo>
                  <a:pt x="20798" y="0"/>
                </a:moveTo>
                <a:cubicBezTo>
                  <a:pt x="21330" y="1897"/>
                  <a:pt x="21600" y="3857"/>
                  <a:pt x="21600" y="5828"/>
                </a:cubicBezTo>
                <a:cubicBezTo>
                  <a:pt x="21600" y="10593"/>
                  <a:pt x="20024" y="15224"/>
                  <a:pt x="17118" y="19001"/>
                </a:cubicBezTo>
                <a:lnTo>
                  <a:pt x="0" y="5828"/>
                </a:lnTo>
                <a:lnTo>
                  <a:pt x="20798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204"/>
          <p:cNvSpPr/>
          <p:nvPr/>
        </p:nvSpPr>
        <p:spPr>
          <a:xfrm>
            <a:off x="3343320" y="3240000"/>
            <a:ext cx="0" cy="82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AutoShape 206"/>
          <p:cNvCxnSpPr>
            <a:stCxn id="50" idx="3"/>
            <a:endCxn id="54" idx="1"/>
          </p:cNvCxnSpPr>
          <p:nvPr/>
        </p:nvCxnSpPr>
        <p:spPr>
          <a:xfrm flipV="1">
            <a:off x="3560760" y="929880"/>
            <a:ext cx="1092600" cy="505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2" name="AutoShape 207"/>
          <p:cNvCxnSpPr/>
          <p:nvPr/>
        </p:nvCxnSpPr>
        <p:spPr>
          <a:xfrm flipV="1" rot="16200000">
            <a:off x="5203440" y="808920"/>
            <a:ext cx="745200" cy="961200"/>
          </a:xfrm>
          <a:prstGeom prst="bent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83" name="Line 241"/>
          <p:cNvSpPr/>
          <p:nvPr/>
        </p:nvSpPr>
        <p:spPr>
          <a:xfrm>
            <a:off x="3346560" y="1547640"/>
            <a:ext cx="0" cy="648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"/>
          <p:cNvGraphicFramePr/>
          <p:nvPr/>
        </p:nvGraphicFramePr>
        <p:xfrm>
          <a:off x="2924280" y="59220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5" name=""/>
          <p:cNvGraphicFramePr/>
          <p:nvPr/>
        </p:nvGraphicFramePr>
        <p:xfrm>
          <a:off x="3913200" y="71748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6" name=""/>
          <p:cNvGraphicFramePr/>
          <p:nvPr/>
        </p:nvGraphicFramePr>
        <p:xfrm>
          <a:off x="5286240" y="736560"/>
          <a:ext cx="658800" cy="37944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,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,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7" name=""/>
          <p:cNvGraphicFramePr/>
          <p:nvPr/>
        </p:nvGraphicFramePr>
        <p:xfrm>
          <a:off x="4527720" y="117468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8" name=""/>
          <p:cNvGraphicFramePr/>
          <p:nvPr/>
        </p:nvGraphicFramePr>
        <p:xfrm>
          <a:off x="3071880" y="1600200"/>
          <a:ext cx="658800" cy="37296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9" name=""/>
          <p:cNvGraphicFramePr/>
          <p:nvPr/>
        </p:nvGraphicFramePr>
        <p:xfrm>
          <a:off x="4071960" y="1889280"/>
          <a:ext cx="658800" cy="37908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0" name=""/>
          <p:cNvGraphicFramePr/>
          <p:nvPr/>
        </p:nvGraphicFramePr>
        <p:xfrm>
          <a:off x="4041720" y="2462040"/>
          <a:ext cx="687600" cy="395640"/>
        </p:xfrm>
        <a:graphic>
          <a:graphicData uri="http://schemas.openxmlformats.org/drawingml/2006/table">
            <a:tbl>
              <a:tblPr/>
              <a:tblGrid>
                <a:gridCol w="293760"/>
                <a:gridCol w="393840"/>
              </a:tblGrid>
              <a:tr h="13176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3176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321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1" name=""/>
          <p:cNvGraphicFramePr/>
          <p:nvPr/>
        </p:nvGraphicFramePr>
        <p:xfrm>
          <a:off x="3071880" y="334800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2" name=""/>
          <p:cNvGraphicFramePr/>
          <p:nvPr/>
        </p:nvGraphicFramePr>
        <p:xfrm>
          <a:off x="4005360" y="3995640"/>
          <a:ext cx="71604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45108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3" name=""/>
          <p:cNvGraphicFramePr/>
          <p:nvPr/>
        </p:nvGraphicFramePr>
        <p:xfrm>
          <a:off x="3141720" y="4697280"/>
          <a:ext cx="612720" cy="379440"/>
        </p:xfrm>
        <a:graphic>
          <a:graphicData uri="http://schemas.openxmlformats.org/drawingml/2006/table">
            <a:tbl>
              <a:tblPr/>
              <a:tblGrid>
                <a:gridCol w="239760"/>
                <a:gridCol w="372960"/>
              </a:tblGrid>
              <a:tr h="12888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4" name=""/>
          <p:cNvGraphicFramePr/>
          <p:nvPr/>
        </p:nvGraphicFramePr>
        <p:xfrm>
          <a:off x="3500280" y="5867280"/>
          <a:ext cx="658800" cy="37944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2888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5" name=""/>
          <p:cNvGraphicFramePr/>
          <p:nvPr/>
        </p:nvGraphicFramePr>
        <p:xfrm>
          <a:off x="3675240" y="174600"/>
          <a:ext cx="977760" cy="501840"/>
        </p:xfrm>
        <a:graphic>
          <a:graphicData uri="http://schemas.openxmlformats.org/drawingml/2006/table">
            <a:tbl>
              <a:tblPr/>
              <a:tblGrid>
                <a:gridCol w="507960"/>
                <a:gridCol w="469800"/>
              </a:tblGrid>
              <a:tr h="12240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a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5f5f5f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 w="5760">
                      <a:solidFill>
                        <a:srgbClr val="5f5f5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5f5f5f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1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88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2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5f5f5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6" name="Text Box 878"/>
          <p:cNvSpPr/>
          <p:nvPr/>
        </p:nvSpPr>
        <p:spPr>
          <a:xfrm>
            <a:off x="3660840" y="34920"/>
            <a:ext cx="165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Glc uptake rate [mmol (gCDW·h)</a:t>
            </a:r>
            <a:r>
              <a:rPr b="1" lang="es-ES" sz="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es-E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7" name="AutoShape 1128"/>
          <p:cNvCxnSpPr>
            <a:stCxn id="53" idx="1"/>
            <a:endCxn id="60" idx="0"/>
          </p:cNvCxnSpPr>
          <p:nvPr/>
        </p:nvCxnSpPr>
        <p:spPr>
          <a:xfrm flipV="1" rot="10800000">
            <a:off x="2328480" y="4204800"/>
            <a:ext cx="800640" cy="2079000"/>
          </a:xfrm>
          <a:prstGeom prst="curved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8" name="72 Rectángulo redondeado"/>
          <p:cNvSpPr/>
          <p:nvPr/>
        </p:nvSpPr>
        <p:spPr>
          <a:xfrm>
            <a:off x="115920" y="826920"/>
            <a:ext cx="2160720" cy="2449800"/>
          </a:xfrm>
          <a:custGeom>
            <a:avLst/>
            <a:gdLst>
              <a:gd name="textAreaLeft" fmla="*/ 105480 w 2160720"/>
              <a:gd name="textAreaRight" fmla="*/ 2055240 w 2160720"/>
              <a:gd name="textAreaTop" fmla="*/ 105480 h 2449800"/>
              <a:gd name="textAreaBottom" fmla="*/ 2344320 h 2449800"/>
            </a:gdLst>
            <a:ahLst/>
            <a:rect l="textAreaLeft" t="textAreaTop" r="textAreaRight" b="textAreaBottom"/>
            <a:pathLst>
              <a:path w="21600" h="24489">
                <a:moveTo>
                  <a:pt x="3600" y="0"/>
                </a:moveTo>
                <a:arcTo wR="3600" hR="3600" stAng="16200000" swAng="-5400000"/>
                <a:lnTo>
                  <a:pt x="0" y="20889"/>
                </a:lnTo>
                <a:arcTo wR="3600" hR="3600" stAng="10800000" swAng="-5400000"/>
                <a:lnTo>
                  <a:pt x="18000" y="24489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6"/>
          <p:cNvSpPr/>
          <p:nvPr/>
        </p:nvSpPr>
        <p:spPr>
          <a:xfrm>
            <a:off x="801720" y="250920"/>
            <a:ext cx="64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MET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138"/>
          <p:cNvSpPr/>
          <p:nvPr/>
        </p:nvSpPr>
        <p:spPr>
          <a:xfrm>
            <a:off x="1125360" y="395280"/>
            <a:ext cx="0" cy="8269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1" name=""/>
          <p:cNvGraphicFramePr/>
          <p:nvPr/>
        </p:nvGraphicFramePr>
        <p:xfrm>
          <a:off x="692280" y="571680"/>
          <a:ext cx="715680" cy="372960"/>
        </p:xfrm>
        <a:graphic>
          <a:graphicData uri="http://schemas.openxmlformats.org/drawingml/2006/table">
            <a:tbl>
              <a:tblPr/>
              <a:tblGrid>
                <a:gridCol w="322200"/>
                <a:gridCol w="393480"/>
              </a:tblGrid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  </a:t>
                      </a: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1.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,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  </a:t>
                      </a: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1.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  </a:t>
                      </a: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1.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02" name="Text Box 12"/>
          <p:cNvSpPr/>
          <p:nvPr/>
        </p:nvSpPr>
        <p:spPr>
          <a:xfrm>
            <a:off x="907920" y="124776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ME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2"/>
          <p:cNvSpPr/>
          <p:nvPr/>
        </p:nvSpPr>
        <p:spPr>
          <a:xfrm>
            <a:off x="873000" y="2044800"/>
            <a:ext cx="50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FOR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4"/>
          <p:cNvSpPr/>
          <p:nvPr/>
        </p:nvSpPr>
        <p:spPr>
          <a:xfrm>
            <a:off x="1557360" y="1692360"/>
            <a:ext cx="44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XU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8"/>
          <p:cNvSpPr/>
          <p:nvPr/>
        </p:nvSpPr>
        <p:spPr>
          <a:xfrm flipH="1">
            <a:off x="1123920" y="1441440"/>
            <a:ext cx="1440" cy="5382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18"/>
          <p:cNvSpPr/>
          <p:nvPr/>
        </p:nvSpPr>
        <p:spPr>
          <a:xfrm>
            <a:off x="1484280" y="29750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GA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8"/>
          <p:cNvSpPr/>
          <p:nvPr/>
        </p:nvSpPr>
        <p:spPr>
          <a:xfrm>
            <a:off x="333360" y="29750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DH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8" name="AutoShape 1163"/>
          <p:cNvCxnSpPr/>
          <p:nvPr/>
        </p:nvCxnSpPr>
        <p:spPr>
          <a:xfrm flipH="1" flipV="1" rot="5400000">
            <a:off x="1778400" y="1901160"/>
            <a:ext cx="118440" cy="2578680"/>
          </a:xfrm>
          <a:prstGeom prst="bentConnector4">
            <a:avLst>
              <a:gd name="adj1" fmla="val -194512"/>
              <a:gd name="adj2" fmla="val 54174"/>
            </a:avLst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09" name="Text Box 18"/>
          <p:cNvSpPr/>
          <p:nvPr/>
        </p:nvSpPr>
        <p:spPr>
          <a:xfrm>
            <a:off x="2565360" y="2046240"/>
            <a:ext cx="4320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CO</a:t>
            </a:r>
            <a:r>
              <a:rPr b="1" lang="es-ES" sz="9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0" name="AutoShape 1165"/>
          <p:cNvCxnSpPr>
            <a:stCxn id="103" idx="2"/>
            <a:endCxn id="107" idx="3"/>
          </p:cNvCxnSpPr>
          <p:nvPr/>
        </p:nvCxnSpPr>
        <p:spPr>
          <a:xfrm rot="5400000">
            <a:off x="537480" y="2503080"/>
            <a:ext cx="815040" cy="360720"/>
          </a:xfrm>
          <a:prstGeom prst="curvedConnector2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11" name="AutoShape 1166"/>
          <p:cNvCxnSpPr>
            <a:stCxn id="103" idx="2"/>
            <a:endCxn id="106" idx="1"/>
          </p:cNvCxnSpPr>
          <p:nvPr/>
        </p:nvCxnSpPr>
        <p:spPr>
          <a:xfrm flipH="1" rot="16200000">
            <a:off x="897480" y="2503440"/>
            <a:ext cx="815040" cy="359280"/>
          </a:xfrm>
          <a:prstGeom prst="curvedConnector2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12" name="Line 1171"/>
          <p:cNvSpPr/>
          <p:nvPr/>
        </p:nvSpPr>
        <p:spPr>
          <a:xfrm flipH="1">
            <a:off x="1483920" y="1835280"/>
            <a:ext cx="730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172"/>
          <p:cNvSpPr/>
          <p:nvPr/>
        </p:nvSpPr>
        <p:spPr>
          <a:xfrm>
            <a:off x="1484280" y="1835280"/>
            <a:ext cx="0" cy="43308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1173"/>
          <p:cNvSpPr/>
          <p:nvPr/>
        </p:nvSpPr>
        <p:spPr>
          <a:xfrm flipH="1">
            <a:off x="1125000" y="2268360"/>
            <a:ext cx="35892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5" name=""/>
          <p:cNvGraphicFramePr/>
          <p:nvPr/>
        </p:nvGraphicFramePr>
        <p:xfrm>
          <a:off x="981000" y="3348000"/>
          <a:ext cx="658800" cy="37944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6" name="Text Box 18"/>
          <p:cNvSpPr/>
          <p:nvPr/>
        </p:nvSpPr>
        <p:spPr>
          <a:xfrm>
            <a:off x="115920" y="1822320"/>
            <a:ext cx="72072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½O</a:t>
            </a:r>
            <a:r>
              <a:rPr b="1" lang="es-ES" sz="9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 + H</a:t>
            </a:r>
            <a:r>
              <a:rPr b="1" lang="es-ES" sz="9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1200"/>
          <p:cNvSpPr/>
          <p:nvPr/>
        </p:nvSpPr>
        <p:spPr>
          <a:xfrm>
            <a:off x="765000" y="1476360"/>
            <a:ext cx="360360" cy="431640"/>
          </a:xfrm>
          <a:custGeom>
            <a:avLst/>
            <a:gdLst>
              <a:gd name="textAreaLeft" fmla="*/ 0 w 360360"/>
              <a:gd name="textAreaRight" fmla="*/ 360720 w 360360"/>
              <a:gd name="textAreaTop" fmla="*/ 0 h 431640"/>
              <a:gd name="textAreaBottom" fmla="*/ 432000 h 431640"/>
            </a:gdLst>
            <a:ahLst/>
            <a:rect l="textAreaLeft" t="textAreaTop" r="textAreaRight" b="textAreaBottom"/>
            <a:pathLst>
              <a:path w="227" h="272">
                <a:moveTo>
                  <a:pt x="227" y="0"/>
                </a:moveTo>
                <a:cubicBezTo>
                  <a:pt x="215" y="49"/>
                  <a:pt x="204" y="98"/>
                  <a:pt x="181" y="136"/>
                </a:cubicBezTo>
                <a:cubicBezTo>
                  <a:pt x="158" y="174"/>
                  <a:pt x="120" y="203"/>
                  <a:pt x="90" y="226"/>
                </a:cubicBezTo>
                <a:cubicBezTo>
                  <a:pt x="60" y="249"/>
                  <a:pt x="30" y="260"/>
                  <a:pt x="0" y="272"/>
                </a:cubicBezTo>
              </a:path>
            </a:pathLst>
          </a:custGeom>
          <a:noFill/>
          <a:ln w="9360">
            <a:solidFill>
              <a:srgbClr val="ff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8" name="AutoShape 1202"/>
          <p:cNvCxnSpPr>
            <a:stCxn id="103" idx="3"/>
            <a:endCxn id="109" idx="1"/>
          </p:cNvCxnSpPr>
          <p:nvPr/>
        </p:nvCxnSpPr>
        <p:spPr>
          <a:xfrm>
            <a:off x="1378080" y="2160360"/>
            <a:ext cx="1187640" cy="11160"/>
          </a:xfrm>
          <a:prstGeom prst="straightConnector1">
            <a:avLst/>
          </a:prstGeom>
          <a:ln w="9360">
            <a:solidFill>
              <a:srgbClr val="ff0000"/>
            </a:solidFill>
            <a:prstDash val="dash"/>
            <a:miter/>
            <a:tailEnd len="med" type="triangle" w="med"/>
          </a:ln>
        </p:spPr>
      </p:cxnSp>
      <p:graphicFrame>
        <p:nvGraphicFramePr>
          <p:cNvPr id="119" name=""/>
          <p:cNvGraphicFramePr/>
          <p:nvPr/>
        </p:nvGraphicFramePr>
        <p:xfrm>
          <a:off x="1628640" y="1979640"/>
          <a:ext cx="658800" cy="39528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4436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1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1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0" name=""/>
          <p:cNvGraphicFramePr/>
          <p:nvPr/>
        </p:nvGraphicFramePr>
        <p:xfrm>
          <a:off x="2133720" y="1547640"/>
          <a:ext cx="658800" cy="3668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</a:t>
                      </a: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1" name=""/>
          <p:cNvGraphicFramePr/>
          <p:nvPr/>
        </p:nvGraphicFramePr>
        <p:xfrm>
          <a:off x="1442880" y="174600"/>
          <a:ext cx="978120" cy="501840"/>
        </p:xfrm>
        <a:graphic>
          <a:graphicData uri="http://schemas.openxmlformats.org/drawingml/2006/table">
            <a:tbl>
              <a:tblPr/>
              <a:tblGrid>
                <a:gridCol w="508320"/>
                <a:gridCol w="469800"/>
              </a:tblGrid>
              <a:tr h="12240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a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5f5f5f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 w="5760">
                      <a:solidFill>
                        <a:srgbClr val="5f5f5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5f5f5f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5f5f5f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1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880"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2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5f5f5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5f5f5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 anchorCtr="1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2" name="Text Box 1247"/>
          <p:cNvSpPr/>
          <p:nvPr/>
        </p:nvSpPr>
        <p:spPr>
          <a:xfrm>
            <a:off x="1428120" y="34920"/>
            <a:ext cx="166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Met uptake rate [mmol (gCDW·h)</a:t>
            </a:r>
            <a:r>
              <a:rPr b="1" lang="es-ES" sz="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es-E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3" name=""/>
          <p:cNvGraphicFramePr/>
          <p:nvPr/>
        </p:nvGraphicFramePr>
        <p:xfrm>
          <a:off x="2857680" y="2428920"/>
          <a:ext cx="617400" cy="372960"/>
        </p:xfrm>
        <a:graphic>
          <a:graphicData uri="http://schemas.openxmlformats.org/drawingml/2006/table">
            <a:tbl>
              <a:tblPr/>
              <a:tblGrid>
                <a:gridCol w="239400"/>
                <a:gridCol w="378000"/>
              </a:tblGrid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4" name=""/>
          <p:cNvGraphicFramePr/>
          <p:nvPr/>
        </p:nvGraphicFramePr>
        <p:xfrm>
          <a:off x="2205000" y="4427640"/>
          <a:ext cx="692280" cy="379440"/>
        </p:xfrm>
        <a:graphic>
          <a:graphicData uri="http://schemas.openxmlformats.org/drawingml/2006/table">
            <a:tbl>
              <a:tblPr/>
              <a:tblGrid>
                <a:gridCol w="239760"/>
                <a:gridCol w="45252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88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5" name=""/>
          <p:cNvGraphicFramePr/>
          <p:nvPr/>
        </p:nvGraphicFramePr>
        <p:xfrm>
          <a:off x="2133720" y="270036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±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6" name=""/>
          <p:cNvGraphicFramePr/>
          <p:nvPr/>
        </p:nvGraphicFramePr>
        <p:xfrm>
          <a:off x="4005360" y="692928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88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7" name=""/>
          <p:cNvGraphicFramePr/>
          <p:nvPr/>
        </p:nvGraphicFramePr>
        <p:xfrm>
          <a:off x="2995560" y="7956720"/>
          <a:ext cx="658800" cy="37908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8" name=""/>
          <p:cNvGraphicFramePr/>
          <p:nvPr/>
        </p:nvGraphicFramePr>
        <p:xfrm>
          <a:off x="1773360" y="6929280"/>
          <a:ext cx="631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66840"/>
              </a:tblGrid>
              <a:tr h="12888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9" name="Line 1490"/>
          <p:cNvSpPr/>
          <p:nvPr/>
        </p:nvSpPr>
        <p:spPr>
          <a:xfrm flipV="1">
            <a:off x="476280" y="8726400"/>
            <a:ext cx="1512720" cy="223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64"/>
          <p:cNvSpPr/>
          <p:nvPr/>
        </p:nvSpPr>
        <p:spPr>
          <a:xfrm>
            <a:off x="1989000" y="8604360"/>
            <a:ext cx="719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BIOMA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1" name=""/>
          <p:cNvGraphicFramePr/>
          <p:nvPr/>
        </p:nvGraphicFramePr>
        <p:xfrm>
          <a:off x="785880" y="8532720"/>
          <a:ext cx="658800" cy="379440"/>
        </p:xfrm>
        <a:graphic>
          <a:graphicData uri="http://schemas.openxmlformats.org/drawingml/2006/table">
            <a:tbl>
              <a:tblPr/>
              <a:tblGrid>
                <a:gridCol w="26496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32" name=""/>
          <p:cNvGraphicFramePr/>
          <p:nvPr/>
        </p:nvGraphicFramePr>
        <p:xfrm>
          <a:off x="5010120" y="2409840"/>
          <a:ext cx="658800" cy="392040"/>
        </p:xfrm>
        <a:graphic>
          <a:graphicData uri="http://schemas.openxmlformats.org/drawingml/2006/table">
            <a:tbl>
              <a:tblPr/>
              <a:tblGrid>
                <a:gridCol w="265320"/>
                <a:gridCol w="393480"/>
              </a:tblGrid>
              <a:tr h="1350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350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04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33" name=""/>
          <p:cNvGraphicFramePr/>
          <p:nvPr/>
        </p:nvGraphicFramePr>
        <p:xfrm>
          <a:off x="4941720" y="8532720"/>
          <a:ext cx="659160" cy="379440"/>
        </p:xfrm>
        <a:graphic>
          <a:graphicData uri="http://schemas.openxmlformats.org/drawingml/2006/table">
            <a:tbl>
              <a:tblPr/>
              <a:tblGrid>
                <a:gridCol w="265320"/>
                <a:gridCol w="393840"/>
              </a:tblGrid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0.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240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28520"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4" name="Text Box 61"/>
          <p:cNvSpPr/>
          <p:nvPr/>
        </p:nvSpPr>
        <p:spPr>
          <a:xfrm>
            <a:off x="4363920" y="8604360"/>
            <a:ext cx="50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NA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61"/>
          <p:cNvSpPr/>
          <p:nvPr/>
        </p:nvSpPr>
        <p:spPr>
          <a:xfrm>
            <a:off x="5877000" y="8604360"/>
            <a:ext cx="504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Calibri"/>
              </a:rPr>
              <a:t>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lecha derecha 98"/>
          <p:cNvSpPr/>
          <p:nvPr/>
        </p:nvSpPr>
        <p:spPr>
          <a:xfrm rot="10409400">
            <a:off x="3012480" y="1271520"/>
            <a:ext cx="215640" cy="2872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lecha derecha 2"/>
          <p:cNvSpPr/>
          <p:nvPr/>
        </p:nvSpPr>
        <p:spPr>
          <a:xfrm rot="2851800">
            <a:off x="5436360" y="4246920"/>
            <a:ext cx="217440" cy="2700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lecha derecha 97"/>
          <p:cNvSpPr/>
          <p:nvPr/>
        </p:nvSpPr>
        <p:spPr>
          <a:xfrm rot="4003800">
            <a:off x="4791600" y="2351880"/>
            <a:ext cx="216000" cy="2872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lecha derecha 100"/>
          <p:cNvSpPr/>
          <p:nvPr/>
        </p:nvSpPr>
        <p:spPr>
          <a:xfrm rot="4003800">
            <a:off x="6087960" y="1847880"/>
            <a:ext cx="216000" cy="2887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lecha derecha 101"/>
          <p:cNvSpPr/>
          <p:nvPr/>
        </p:nvSpPr>
        <p:spPr>
          <a:xfrm rot="3090600">
            <a:off x="3356640" y="3072600"/>
            <a:ext cx="216000" cy="2872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lecha derecha 102"/>
          <p:cNvSpPr/>
          <p:nvPr/>
        </p:nvSpPr>
        <p:spPr>
          <a:xfrm rot="2790000">
            <a:off x="2419920" y="6405840"/>
            <a:ext cx="215640" cy="2876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lecha derecha 103"/>
          <p:cNvSpPr/>
          <p:nvPr/>
        </p:nvSpPr>
        <p:spPr>
          <a:xfrm rot="2710200">
            <a:off x="3426840" y="4245120"/>
            <a:ext cx="216000" cy="2890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lecha derecha 104"/>
          <p:cNvSpPr/>
          <p:nvPr/>
        </p:nvSpPr>
        <p:spPr>
          <a:xfrm rot="3135600">
            <a:off x="4287600" y="7769160"/>
            <a:ext cx="215640" cy="2890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lecha derecha 105"/>
          <p:cNvSpPr/>
          <p:nvPr/>
        </p:nvSpPr>
        <p:spPr>
          <a:xfrm rot="2790000">
            <a:off x="334440" y="8571240"/>
            <a:ext cx="215640" cy="2872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6T16:30:34Z</dcterms:created>
  <dc:creator>kbaumann</dc:creator>
  <dc:description/>
  <dc:language>en-US</dc:language>
  <cp:lastModifiedBy>Usuario de Windows</cp:lastModifiedBy>
  <dcterms:modified xsi:type="dcterms:W3CDTF">2012-03-28T14:40:24Z</dcterms:modified>
  <cp:revision>74</cp:revision>
  <dc:subject/>
  <dc:title>Diapositiva 1</dc:title>
</cp:coreProperties>
</file>